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142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4077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6375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20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1971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053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4662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046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6208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1689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4302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6085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A284D-31B8-47E6-AC00-5BC9DC666D6A}" type="datetimeFigureOut">
              <a:rPr lang="it-IT" smtClean="0"/>
              <a:t>08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A0B89-D06E-4647-AEC3-447E08EA07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915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292608" y="351801"/>
            <a:ext cx="8394192" cy="5774678"/>
            <a:chOff x="292608" y="351801"/>
            <a:chExt cx="8394192" cy="5774678"/>
          </a:xfrm>
        </p:grpSpPr>
        <p:grpSp>
          <p:nvGrpSpPr>
            <p:cNvPr id="26" name="Gruppo 25"/>
            <p:cNvGrpSpPr/>
            <p:nvPr/>
          </p:nvGrpSpPr>
          <p:grpSpPr>
            <a:xfrm>
              <a:off x="292608" y="1250942"/>
              <a:ext cx="7836408" cy="4875537"/>
              <a:chOff x="292608" y="1250942"/>
              <a:chExt cx="7836408" cy="4875537"/>
            </a:xfrm>
          </p:grpSpPr>
          <p:pic>
            <p:nvPicPr>
              <p:cNvPr id="4" name="Immagine 3"/>
              <p:cNvPicPr/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2608" y="1335024"/>
                <a:ext cx="6016752" cy="4791455"/>
              </a:xfrm>
              <a:prstGeom prst="rect">
                <a:avLst/>
              </a:prstGeom>
              <a:noFill/>
              <a:ln>
                <a:noFill/>
              </a:ln>
            </p:spPr>
          </p:pic>
          <p:grpSp>
            <p:nvGrpSpPr>
              <p:cNvPr id="21" name="Gruppo 20"/>
              <p:cNvGrpSpPr/>
              <p:nvPr/>
            </p:nvGrpSpPr>
            <p:grpSpPr>
              <a:xfrm>
                <a:off x="4736592" y="1645920"/>
                <a:ext cx="1980009" cy="1042416"/>
                <a:chOff x="4791456" y="1179576"/>
                <a:chExt cx="1980009" cy="1042416"/>
              </a:xfrm>
            </p:grpSpPr>
            <p:sp>
              <p:nvSpPr>
                <p:cNvPr id="8" name="Rettangolo 7"/>
                <p:cNvSpPr/>
                <p:nvPr/>
              </p:nvSpPr>
              <p:spPr>
                <a:xfrm>
                  <a:off x="4791456" y="1179576"/>
                  <a:ext cx="1188720" cy="10424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" name="CasellaDiTesto 6"/>
                <p:cNvSpPr txBox="1"/>
                <p:nvPr/>
              </p:nvSpPr>
              <p:spPr>
                <a:xfrm>
                  <a:off x="5148905" y="1390995"/>
                  <a:ext cx="1622560" cy="83099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dirty="0"/>
                    <a:t>Model</a:t>
                  </a:r>
                </a:p>
                <a:p>
                  <a:r>
                    <a:rPr lang="it-IT" sz="1200" b="1" dirty="0"/>
                    <a:t>IGF-1 </a:t>
                  </a:r>
                  <a:r>
                    <a:rPr lang="it-IT" sz="1200" b="1" dirty="0" err="1"/>
                    <a:t>xULN</a:t>
                  </a:r>
                  <a:r>
                    <a:rPr lang="it-IT" sz="1200" b="1" dirty="0"/>
                    <a:t> (</a:t>
                  </a:r>
                  <a:r>
                    <a:rPr lang="it-IT" sz="1200" b="1" dirty="0" err="1"/>
                    <a:t>diagnosis</a:t>
                  </a:r>
                  <a:r>
                    <a:rPr lang="it-IT" sz="1200" b="1" dirty="0"/>
                    <a:t>)</a:t>
                  </a:r>
                </a:p>
                <a:p>
                  <a:r>
                    <a:rPr lang="it-IT" sz="1200" b="1" dirty="0"/>
                    <a:t>T2-hypointense </a:t>
                  </a:r>
                  <a:r>
                    <a:rPr lang="it-IT" sz="1200" b="1" dirty="0" err="1"/>
                    <a:t>tumor</a:t>
                  </a:r>
                  <a:endParaRPr lang="it-IT" sz="1200" b="1" dirty="0"/>
                </a:p>
                <a:p>
                  <a:r>
                    <a:rPr lang="it-IT" sz="1200" b="1" dirty="0"/>
                    <a:t>Age ≤ 40 </a:t>
                  </a:r>
                  <a:r>
                    <a:rPr lang="it-IT" sz="1200" b="1" dirty="0" err="1"/>
                    <a:t>years</a:t>
                  </a:r>
                  <a:endParaRPr lang="it-IT" sz="1200" b="1" dirty="0"/>
                </a:p>
              </p:txBody>
            </p:sp>
            <p:cxnSp>
              <p:nvCxnSpPr>
                <p:cNvPr id="10" name="Connettore diritto 9"/>
                <p:cNvCxnSpPr/>
                <p:nvPr/>
              </p:nvCxnSpPr>
              <p:spPr>
                <a:xfrm flipV="1">
                  <a:off x="4930972" y="1517904"/>
                  <a:ext cx="228600" cy="2649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Connettore diritto 11"/>
                <p:cNvCxnSpPr/>
                <p:nvPr/>
              </p:nvCxnSpPr>
              <p:spPr>
                <a:xfrm flipV="1">
                  <a:off x="4930972" y="1722729"/>
                  <a:ext cx="228600" cy="2649"/>
                </a:xfrm>
                <a:prstGeom prst="line">
                  <a:avLst/>
                </a:prstGeom>
                <a:ln w="285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Connettore diritto 12"/>
                <p:cNvCxnSpPr/>
                <p:nvPr/>
              </p:nvCxnSpPr>
              <p:spPr>
                <a:xfrm flipV="1">
                  <a:off x="4930972" y="1899362"/>
                  <a:ext cx="228600" cy="2649"/>
                </a:xfrm>
                <a:prstGeom prst="line">
                  <a:avLst/>
                </a:prstGeom>
                <a:ln w="28575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Connettore diritto 13"/>
                <p:cNvCxnSpPr/>
                <p:nvPr/>
              </p:nvCxnSpPr>
              <p:spPr>
                <a:xfrm flipV="1">
                  <a:off x="4930972" y="2074700"/>
                  <a:ext cx="228600" cy="2649"/>
                </a:xfrm>
                <a:prstGeom prst="line">
                  <a:avLst/>
                </a:prstGeom>
                <a:ln w="28575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" name="Rettangolo 14"/>
              <p:cNvSpPr/>
              <p:nvPr/>
            </p:nvSpPr>
            <p:spPr>
              <a:xfrm>
                <a:off x="2798064" y="1316736"/>
                <a:ext cx="1106424" cy="3108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6" name="Rettangolo 15"/>
              <p:cNvSpPr/>
              <p:nvPr/>
            </p:nvSpPr>
            <p:spPr>
              <a:xfrm rot="16200000">
                <a:off x="-18288" y="3338354"/>
                <a:ext cx="1106424" cy="3108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7" name="Rettangolo 16"/>
              <p:cNvSpPr/>
              <p:nvPr/>
            </p:nvSpPr>
            <p:spPr>
              <a:xfrm>
                <a:off x="1737360" y="5566440"/>
                <a:ext cx="3138748" cy="56003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" name="CasellaDiTesto 17"/>
              <p:cNvSpPr txBox="1"/>
              <p:nvPr/>
            </p:nvSpPr>
            <p:spPr>
              <a:xfrm>
                <a:off x="2403286" y="1250942"/>
                <a:ext cx="9507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/>
                  <a:t>ROC curve</a:t>
                </a:r>
              </a:p>
            </p:txBody>
          </p:sp>
          <p:pic>
            <p:nvPicPr>
              <p:cNvPr id="20" name="Immagine 19"/>
              <p:cNvPicPr>
                <a:picLocks noChangeAspect="1"/>
              </p:cNvPicPr>
              <p:nvPr/>
            </p:nvPicPr>
            <p:blipFill rotWithShape="1">
              <a:blip r:embed="rId3"/>
              <a:srcRect r="29126"/>
              <a:stretch/>
            </p:blipFill>
            <p:spPr>
              <a:xfrm>
                <a:off x="3904488" y="3387157"/>
                <a:ext cx="4224528" cy="1480461"/>
              </a:xfrm>
              <a:prstGeom prst="rect">
                <a:avLst/>
              </a:prstGeom>
            </p:spPr>
          </p:pic>
          <p:sp>
            <p:nvSpPr>
              <p:cNvPr id="22" name="CasellaDiTesto 21"/>
              <p:cNvSpPr txBox="1"/>
              <p:nvPr/>
            </p:nvSpPr>
            <p:spPr>
              <a:xfrm rot="16200000">
                <a:off x="147901" y="3192948"/>
                <a:ext cx="9509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 err="1"/>
                  <a:t>Sensibility</a:t>
                </a:r>
                <a:endParaRPr lang="it-IT" sz="1400" b="1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2403286" y="5566440"/>
                <a:ext cx="117051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/>
                  <a:t>1 - </a:t>
                </a:r>
                <a:r>
                  <a:rPr lang="it-IT" sz="1400" b="1" dirty="0" err="1"/>
                  <a:t>Specificity</a:t>
                </a:r>
                <a:endParaRPr lang="it-IT" sz="1400" b="1" dirty="0"/>
              </a:p>
            </p:txBody>
          </p:sp>
        </p:grpSp>
        <p:sp>
          <p:nvSpPr>
            <p:cNvPr id="25" name="Rettangolo 24"/>
            <p:cNvSpPr/>
            <p:nvPr/>
          </p:nvSpPr>
          <p:spPr>
            <a:xfrm>
              <a:off x="338328" y="351801"/>
              <a:ext cx="8348472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.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4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ceiver-operating-characteristics (ROC)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rves for the calculation of the distinctive ability of different parameters (alone or combined as a Model) to identify patients that will show a &gt;50% IGF-1 reduction</a:t>
              </a:r>
              <a:endParaRPr lang="it-IT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7142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</TotalTime>
  <Words>57</Words>
  <Application>Microsoft Office PowerPoint</Application>
  <PresentationFormat>Presentazione su schermo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ser</dc:creator>
  <cp:lastModifiedBy>user</cp:lastModifiedBy>
  <cp:revision>11</cp:revision>
  <dcterms:created xsi:type="dcterms:W3CDTF">2021-03-05T11:15:29Z</dcterms:created>
  <dcterms:modified xsi:type="dcterms:W3CDTF">2021-03-08T10:29:41Z</dcterms:modified>
</cp:coreProperties>
</file>